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sk-S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AF2F3B0-D59E-4228-A48F-4A9EA1E103EF}" v="3" dt="2024-04-23T09:14:48.3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20" d="100"/>
          <a:sy n="120" d="100"/>
        </p:scale>
        <p:origin x="96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a Grejtakova" userId="bbcbf34c4b1c4e42" providerId="LiveId" clId="{5AF2F3B0-D59E-4228-A48F-4A9EA1E103EF}"/>
    <pc:docChg chg="undo custSel modSld">
      <pc:chgData name="Daniela Grejtakova" userId="bbcbf34c4b1c4e42" providerId="LiveId" clId="{5AF2F3B0-D59E-4228-A48F-4A9EA1E103EF}" dt="2024-04-23T09:14:52.260" v="8" actId="1076"/>
      <pc:docMkLst>
        <pc:docMk/>
      </pc:docMkLst>
      <pc:sldChg chg="addSp delSp modSp mod">
        <pc:chgData name="Daniela Grejtakova" userId="bbcbf34c4b1c4e42" providerId="LiveId" clId="{5AF2F3B0-D59E-4228-A48F-4A9EA1E103EF}" dt="2024-04-23T09:14:52.260" v="8" actId="1076"/>
        <pc:sldMkLst>
          <pc:docMk/>
          <pc:sldMk cId="3546418112" sldId="258"/>
        </pc:sldMkLst>
        <pc:cxnChg chg="del mod">
          <ac:chgData name="Daniela Grejtakova" userId="bbcbf34c4b1c4e42" providerId="LiveId" clId="{5AF2F3B0-D59E-4228-A48F-4A9EA1E103EF}" dt="2024-04-23T09:14:44.101" v="6" actId="478"/>
          <ac:cxnSpMkLst>
            <pc:docMk/>
            <pc:sldMk cId="3546418112" sldId="258"/>
            <ac:cxnSpMk id="3" creationId="{6D86AC31-1EE2-1931-68BC-8FC44D8280DF}"/>
          </ac:cxnSpMkLst>
        </pc:cxnChg>
        <pc:cxnChg chg="add mod">
          <ac:chgData name="Daniela Grejtakova" userId="bbcbf34c4b1c4e42" providerId="LiveId" clId="{5AF2F3B0-D59E-4228-A48F-4A9EA1E103EF}" dt="2024-04-23T09:14:40.910" v="4" actId="1076"/>
          <ac:cxnSpMkLst>
            <pc:docMk/>
            <pc:sldMk cId="3546418112" sldId="258"/>
            <ac:cxnSpMk id="4" creationId="{031F84E7-EAEF-D62F-54A0-11465E141E9F}"/>
          </ac:cxnSpMkLst>
        </pc:cxnChg>
        <pc:cxnChg chg="add mod">
          <ac:chgData name="Daniela Grejtakova" userId="bbcbf34c4b1c4e42" providerId="LiveId" clId="{5AF2F3B0-D59E-4228-A48F-4A9EA1E103EF}" dt="2024-04-23T09:14:52.260" v="8" actId="1076"/>
          <ac:cxnSpMkLst>
            <pc:docMk/>
            <pc:sldMk cId="3546418112" sldId="258"/>
            <ac:cxnSpMk id="9" creationId="{E39CB17E-66CF-33EA-1659-B8A87A526C26}"/>
          </ac:cxnSpMkLst>
        </pc:cxnChg>
        <pc:cxnChg chg="add del">
          <ac:chgData name="Daniela Grejtakova" userId="bbcbf34c4b1c4e42" providerId="LiveId" clId="{5AF2F3B0-D59E-4228-A48F-4A9EA1E103EF}" dt="2024-04-23T09:14:41.999" v="5" actId="478"/>
          <ac:cxnSpMkLst>
            <pc:docMk/>
            <pc:sldMk cId="3546418112" sldId="258"/>
            <ac:cxnSpMk id="75" creationId="{2BC9725C-EA7E-8425-9315-1CFAB0E9C84F}"/>
          </ac:cxnSpMkLst>
        </pc:cxnChg>
      </pc:sldChg>
    </pc:docChg>
  </pc:docChgLst>
  <pc:docChgLst>
    <pc:chgData name="Daniela Grejtakova" userId="bbcbf34c4b1c4e42" providerId="LiveId" clId="{B79B3BB6-BE0D-41FF-9837-DA5EA1766366}"/>
    <pc:docChg chg="undo custSel addSld delSld modSld">
      <pc:chgData name="Daniela Grejtakova" userId="bbcbf34c4b1c4e42" providerId="LiveId" clId="{B79B3BB6-BE0D-41FF-9837-DA5EA1766366}" dt="2024-04-12T09:12:41.103" v="372" actId="2696"/>
      <pc:docMkLst>
        <pc:docMk/>
      </pc:docMkLst>
      <pc:sldChg chg="addSp modSp mod">
        <pc:chgData name="Daniela Grejtakova" userId="bbcbf34c4b1c4e42" providerId="LiveId" clId="{B79B3BB6-BE0D-41FF-9837-DA5EA1766366}" dt="2024-04-12T09:12:29.221" v="371" actId="313"/>
        <pc:sldMkLst>
          <pc:docMk/>
          <pc:sldMk cId="3546418112" sldId="258"/>
        </pc:sldMkLst>
        <pc:spChg chg="mod">
          <ac:chgData name="Daniela Grejtakova" userId="bbcbf34c4b1c4e42" providerId="LiveId" clId="{B79B3BB6-BE0D-41FF-9837-DA5EA1766366}" dt="2024-04-12T09:10:18.299" v="353" actId="2711"/>
          <ac:spMkLst>
            <pc:docMk/>
            <pc:sldMk cId="3546418112" sldId="258"/>
            <ac:spMk id="5" creationId="{F4FB9BE5-4250-FDD0-4D18-8E146522EF20}"/>
          </ac:spMkLst>
        </pc:spChg>
        <pc:spChg chg="mod">
          <ac:chgData name="Daniela Grejtakova" userId="bbcbf34c4b1c4e42" providerId="LiveId" clId="{B79B3BB6-BE0D-41FF-9837-DA5EA1766366}" dt="2024-04-12T09:10:18.299" v="353" actId="2711"/>
          <ac:spMkLst>
            <pc:docMk/>
            <pc:sldMk cId="3546418112" sldId="258"/>
            <ac:spMk id="6" creationId="{35A8592C-99B4-8F25-0B94-86AE0B0D64B5}"/>
          </ac:spMkLst>
        </pc:spChg>
        <pc:spChg chg="mod">
          <ac:chgData name="Daniela Grejtakova" userId="bbcbf34c4b1c4e42" providerId="LiveId" clId="{B79B3BB6-BE0D-41FF-9837-DA5EA1766366}" dt="2024-04-12T09:10:18.299" v="353" actId="2711"/>
          <ac:spMkLst>
            <pc:docMk/>
            <pc:sldMk cId="3546418112" sldId="258"/>
            <ac:spMk id="7" creationId="{258D1F6C-C102-AF36-6D8C-9644CEE46D1C}"/>
          </ac:spMkLst>
        </pc:spChg>
        <pc:spChg chg="mod">
          <ac:chgData name="Daniela Grejtakova" userId="bbcbf34c4b1c4e42" providerId="LiveId" clId="{B79B3BB6-BE0D-41FF-9837-DA5EA1766366}" dt="2024-04-12T09:12:29.221" v="371" actId="313"/>
          <ac:spMkLst>
            <pc:docMk/>
            <pc:sldMk cId="3546418112" sldId="258"/>
            <ac:spMk id="8" creationId="{457655E7-7C20-C570-C003-8196B7A99169}"/>
          </ac:spMkLst>
        </pc:spChg>
        <pc:spChg chg="mod">
          <ac:chgData name="Daniela Grejtakova" userId="bbcbf34c4b1c4e42" providerId="LiveId" clId="{B79B3BB6-BE0D-41FF-9837-DA5EA1766366}" dt="2024-04-12T09:11:22.654" v="362" actId="20577"/>
          <ac:spMkLst>
            <pc:docMk/>
            <pc:sldMk cId="3546418112" sldId="258"/>
            <ac:spMk id="10" creationId="{ECAE5202-F549-4064-F796-2B780E79FDFE}"/>
          </ac:spMkLst>
        </pc:spChg>
        <pc:spChg chg="mod">
          <ac:chgData name="Daniela Grejtakova" userId="bbcbf34c4b1c4e42" providerId="LiveId" clId="{B79B3BB6-BE0D-41FF-9837-DA5EA1766366}" dt="2024-04-12T09:12:08.817" v="370" actId="790"/>
          <ac:spMkLst>
            <pc:docMk/>
            <pc:sldMk cId="3546418112" sldId="258"/>
            <ac:spMk id="12" creationId="{34458C7A-4A72-CBF4-B4D4-E04EA6221463}"/>
          </ac:spMkLst>
        </pc:spChg>
        <pc:spChg chg="mod">
          <ac:chgData name="Daniela Grejtakova" userId="bbcbf34c4b1c4e42" providerId="LiveId" clId="{B79B3BB6-BE0D-41FF-9837-DA5EA1766366}" dt="2024-04-12T09:10:18.299" v="353" actId="2711"/>
          <ac:spMkLst>
            <pc:docMk/>
            <pc:sldMk cId="3546418112" sldId="258"/>
            <ac:spMk id="14" creationId="{9446ACD4-404D-D3F3-F6D0-276F94909D10}"/>
          </ac:spMkLst>
        </pc:spChg>
        <pc:spChg chg="mod">
          <ac:chgData name="Daniela Grejtakova" userId="bbcbf34c4b1c4e42" providerId="LiveId" clId="{B79B3BB6-BE0D-41FF-9837-DA5EA1766366}" dt="2024-04-12T09:10:59.779" v="357" actId="1076"/>
          <ac:spMkLst>
            <pc:docMk/>
            <pc:sldMk cId="3546418112" sldId="258"/>
            <ac:spMk id="16" creationId="{83C01A86-470E-5FD4-5639-6D8FA8163D93}"/>
          </ac:spMkLst>
        </pc:spChg>
        <pc:spChg chg="mod">
          <ac:chgData name="Daniela Grejtakova" userId="bbcbf34c4b1c4e42" providerId="LiveId" clId="{B79B3BB6-BE0D-41FF-9837-DA5EA1766366}" dt="2024-04-12T09:10:28.877" v="355" actId="20577"/>
          <ac:spMkLst>
            <pc:docMk/>
            <pc:sldMk cId="3546418112" sldId="258"/>
            <ac:spMk id="18" creationId="{8B305C6A-6899-31D1-36F6-C323FDD7A17A}"/>
          </ac:spMkLst>
        </pc:spChg>
        <pc:spChg chg="mod">
          <ac:chgData name="Daniela Grejtakova" userId="bbcbf34c4b1c4e42" providerId="LiveId" clId="{B79B3BB6-BE0D-41FF-9837-DA5EA1766366}" dt="2024-04-12T09:11:52.953" v="368" actId="1076"/>
          <ac:spMkLst>
            <pc:docMk/>
            <pc:sldMk cId="3546418112" sldId="258"/>
            <ac:spMk id="20" creationId="{5789F68F-67E2-452C-DABF-13DAB0503E47}"/>
          </ac:spMkLst>
        </pc:spChg>
        <pc:spChg chg="mod">
          <ac:chgData name="Daniela Grejtakova" userId="bbcbf34c4b1c4e42" providerId="LiveId" clId="{B79B3BB6-BE0D-41FF-9837-DA5EA1766366}" dt="2024-04-12T09:10:18.299" v="353" actId="2711"/>
          <ac:spMkLst>
            <pc:docMk/>
            <pc:sldMk cId="3546418112" sldId="258"/>
            <ac:spMk id="22" creationId="{3AE1DAA4-71F3-93B9-9E48-8035A81005AE}"/>
          </ac:spMkLst>
        </pc:spChg>
        <pc:spChg chg="add mod">
          <ac:chgData name="Daniela Grejtakova" userId="bbcbf34c4b1c4e42" providerId="LiveId" clId="{B79B3BB6-BE0D-41FF-9837-DA5EA1766366}" dt="2024-04-12T09:10:18.299" v="353" actId="2711"/>
          <ac:spMkLst>
            <pc:docMk/>
            <pc:sldMk cId="3546418112" sldId="258"/>
            <ac:spMk id="25" creationId="{AA8BC700-C1D1-64C0-6677-D5AD83B82ACE}"/>
          </ac:spMkLst>
        </pc:spChg>
        <pc:spChg chg="mod">
          <ac:chgData name="Daniela Grejtakova" userId="bbcbf34c4b1c4e42" providerId="LiveId" clId="{B79B3BB6-BE0D-41FF-9837-DA5EA1766366}" dt="2024-04-12T09:10:51.891" v="356" actId="14100"/>
          <ac:spMkLst>
            <pc:docMk/>
            <pc:sldMk cId="3546418112" sldId="258"/>
            <ac:spMk id="33" creationId="{4B979C71-7240-4B75-582A-BEBC0CCAB112}"/>
          </ac:spMkLst>
        </pc:spChg>
        <pc:cxnChg chg="mod">
          <ac:chgData name="Daniela Grejtakova" userId="bbcbf34c4b1c4e42" providerId="LiveId" clId="{B79B3BB6-BE0D-41FF-9837-DA5EA1766366}" dt="2024-04-12T09:08:56.578" v="336" actId="1076"/>
          <ac:cxnSpMkLst>
            <pc:docMk/>
            <pc:sldMk cId="3546418112" sldId="258"/>
            <ac:cxnSpMk id="3" creationId="{6D86AC31-1EE2-1931-68BC-8FC44D8280DF}"/>
          </ac:cxnSpMkLst>
        </pc:cxnChg>
        <pc:cxnChg chg="mod">
          <ac:chgData name="Daniela Grejtakova" userId="bbcbf34c4b1c4e42" providerId="LiveId" clId="{B79B3BB6-BE0D-41FF-9837-DA5EA1766366}" dt="2024-04-12T09:11:33.796" v="364" actId="1076"/>
          <ac:cxnSpMkLst>
            <pc:docMk/>
            <pc:sldMk cId="3546418112" sldId="258"/>
            <ac:cxnSpMk id="13" creationId="{57E99F59-C795-F224-AC04-E3A6A0F57A30}"/>
          </ac:cxnSpMkLst>
        </pc:cxnChg>
        <pc:cxnChg chg="mod">
          <ac:chgData name="Daniela Grejtakova" userId="bbcbf34c4b1c4e42" providerId="LiveId" clId="{B79B3BB6-BE0D-41FF-9837-DA5EA1766366}" dt="2024-04-12T09:08:07.700" v="317" actId="1076"/>
          <ac:cxnSpMkLst>
            <pc:docMk/>
            <pc:sldMk cId="3546418112" sldId="258"/>
            <ac:cxnSpMk id="75" creationId="{2BC9725C-EA7E-8425-9315-1CFAB0E9C84F}"/>
          </ac:cxnSpMkLst>
        </pc:cxnChg>
        <pc:cxnChg chg="mod">
          <ac:chgData name="Daniela Grejtakova" userId="bbcbf34c4b1c4e42" providerId="LiveId" clId="{B79B3BB6-BE0D-41FF-9837-DA5EA1766366}" dt="2024-04-12T09:08:46.636" v="332" actId="1076"/>
          <ac:cxnSpMkLst>
            <pc:docMk/>
            <pc:sldMk cId="3546418112" sldId="258"/>
            <ac:cxnSpMk id="76" creationId="{08E3043D-6ADF-082C-3570-5DCC5ADE048D}"/>
          </ac:cxnSpMkLst>
        </pc:cxnChg>
        <pc:cxnChg chg="mod">
          <ac:chgData name="Daniela Grejtakova" userId="bbcbf34c4b1c4e42" providerId="LiveId" clId="{B79B3BB6-BE0D-41FF-9837-DA5EA1766366}" dt="2024-04-12T09:08:54.892" v="335" actId="1076"/>
          <ac:cxnSpMkLst>
            <pc:docMk/>
            <pc:sldMk cId="3546418112" sldId="258"/>
            <ac:cxnSpMk id="77" creationId="{ADCF4E17-5EA3-6CD4-692F-DDC6158FEA50}"/>
          </ac:cxnSpMkLst>
        </pc:cxnChg>
        <pc:cxnChg chg="mod">
          <ac:chgData name="Daniela Grejtakova" userId="bbcbf34c4b1c4e42" providerId="LiveId" clId="{B79B3BB6-BE0D-41FF-9837-DA5EA1766366}" dt="2024-04-12T09:11:53.386" v="369" actId="1076"/>
          <ac:cxnSpMkLst>
            <pc:docMk/>
            <pc:sldMk cId="3546418112" sldId="258"/>
            <ac:cxnSpMk id="78" creationId="{5713185A-6972-EDEC-1606-584722A2BCB7}"/>
          </ac:cxnSpMkLst>
        </pc:cxnChg>
      </pc:sldChg>
      <pc:sldChg chg="addSp delSp modSp new del mod">
        <pc:chgData name="Daniela Grejtakova" userId="bbcbf34c4b1c4e42" providerId="LiveId" clId="{B79B3BB6-BE0D-41FF-9837-DA5EA1766366}" dt="2024-04-12T09:12:41.103" v="372" actId="2696"/>
        <pc:sldMkLst>
          <pc:docMk/>
          <pc:sldMk cId="3368625721" sldId="259"/>
        </pc:sldMkLst>
        <pc:spChg chg="add del">
          <ac:chgData name="Daniela Grejtakova" userId="bbcbf34c4b1c4e42" providerId="LiveId" clId="{B79B3BB6-BE0D-41FF-9837-DA5EA1766366}" dt="2024-04-12T09:01:13.059" v="190" actId="478"/>
          <ac:spMkLst>
            <pc:docMk/>
            <pc:sldMk cId="3368625721" sldId="259"/>
            <ac:spMk id="2" creationId="{90EABDCF-4373-85CE-08EA-22C8F07269FB}"/>
          </ac:spMkLst>
        </pc:spChg>
        <pc:spChg chg="del mod">
          <ac:chgData name="Daniela Grejtakova" userId="bbcbf34c4b1c4e42" providerId="LiveId" clId="{B79B3BB6-BE0D-41FF-9837-DA5EA1766366}" dt="2024-04-12T09:04:47.296" v="262" actId="478"/>
          <ac:spMkLst>
            <pc:docMk/>
            <pc:sldMk cId="3368625721" sldId="259"/>
            <ac:spMk id="3" creationId="{4E879C7D-B758-5518-E500-CB9868390B31}"/>
          </ac:spMkLst>
        </pc:spChg>
        <pc:spChg chg="add mod">
          <ac:chgData name="Daniela Grejtakova" userId="bbcbf34c4b1c4e42" providerId="LiveId" clId="{B79B3BB6-BE0D-41FF-9837-DA5EA1766366}" dt="2024-04-12T09:04:57.705" v="266" actId="404"/>
          <ac:spMkLst>
            <pc:docMk/>
            <pc:sldMk cId="3368625721" sldId="259"/>
            <ac:spMk id="5" creationId="{1249AB5C-8977-9E79-8531-90C541AF4538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6" creationId="{F36DCABD-E661-BEE4-7A83-699FCFF7F789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7" creationId="{0D38ACA9-7484-C08A-4BE9-23416FB458BF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8" creationId="{4B3FDBBD-B766-763B-D547-4A54EB35D3C3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9" creationId="{0264DC41-6B9D-6F1D-3F16-06555B37F9F9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0" creationId="{54474B03-0020-9997-7B7F-780C2BCB0A22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1" creationId="{78201A4D-59F7-BD60-B57A-0555BF64BEFA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2" creationId="{D8C52B83-4A87-1EE8-B62E-C41DD7951505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3" creationId="{5EF7520E-BBBD-B7A4-956C-9B87010CF2B0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4" creationId="{341DB51B-8364-CE91-9CC4-9B59FCB7DA0C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5" creationId="{D89C5319-0243-985A-17AE-3797D665DA81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6" creationId="{7B58CE1C-2224-EB77-FFCF-4B5FF296135C}"/>
          </ac:spMkLst>
        </pc:spChg>
        <pc:spChg chg="add mod">
          <ac:chgData name="Daniela Grejtakova" userId="bbcbf34c4b1c4e42" providerId="LiveId" clId="{B79B3BB6-BE0D-41FF-9837-DA5EA1766366}" dt="2024-04-12T09:05:35.052" v="273" actId="1076"/>
          <ac:spMkLst>
            <pc:docMk/>
            <pc:sldMk cId="3368625721" sldId="259"/>
            <ac:spMk id="19" creationId="{9146F2BE-804F-C622-9FC8-1F2D7A02B9DC}"/>
          </ac:spMkLst>
        </pc:spChg>
        <pc:cxnChg chg="add mod">
          <ac:chgData name="Daniela Grejtakova" userId="bbcbf34c4b1c4e42" providerId="LiveId" clId="{B79B3BB6-BE0D-41FF-9837-DA5EA1766366}" dt="2024-04-12T09:05:35.052" v="273" actId="1076"/>
          <ac:cxnSpMkLst>
            <pc:docMk/>
            <pc:sldMk cId="3368625721" sldId="259"/>
            <ac:cxnSpMk id="17" creationId="{91E30E67-D81C-83DE-9B9E-BA54A18FEFA3}"/>
          </ac:cxnSpMkLst>
        </pc:cxnChg>
        <pc:cxnChg chg="add mod">
          <ac:chgData name="Daniela Grejtakova" userId="bbcbf34c4b1c4e42" providerId="LiveId" clId="{B79B3BB6-BE0D-41FF-9837-DA5EA1766366}" dt="2024-04-12T09:05:35.052" v="273" actId="1076"/>
          <ac:cxnSpMkLst>
            <pc:docMk/>
            <pc:sldMk cId="3368625721" sldId="259"/>
            <ac:cxnSpMk id="18" creationId="{0BB2F87B-1AFA-501A-2C0F-8E3A4CBF183A}"/>
          </ac:cxnSpMkLst>
        </pc:cxnChg>
        <pc:cxnChg chg="add mod">
          <ac:chgData name="Daniela Grejtakova" userId="bbcbf34c4b1c4e42" providerId="LiveId" clId="{B79B3BB6-BE0D-41FF-9837-DA5EA1766366}" dt="2024-04-12T09:05:35.052" v="273" actId="1076"/>
          <ac:cxnSpMkLst>
            <pc:docMk/>
            <pc:sldMk cId="3368625721" sldId="259"/>
            <ac:cxnSpMk id="20" creationId="{97DB4016-299B-804A-E8C5-FF48D2C07AED}"/>
          </ac:cxnSpMkLst>
        </pc:cxnChg>
        <pc:cxnChg chg="add mod">
          <ac:chgData name="Daniela Grejtakova" userId="bbcbf34c4b1c4e42" providerId="LiveId" clId="{B79B3BB6-BE0D-41FF-9837-DA5EA1766366}" dt="2024-04-12T09:05:35.052" v="273" actId="1076"/>
          <ac:cxnSpMkLst>
            <pc:docMk/>
            <pc:sldMk cId="3368625721" sldId="259"/>
            <ac:cxnSpMk id="21" creationId="{3DAE6E04-50FF-3B4D-8AB8-4EB236D6A411}"/>
          </ac:cxnSpMkLst>
        </pc:cxnChg>
        <pc:cxnChg chg="add mod">
          <ac:chgData name="Daniela Grejtakova" userId="bbcbf34c4b1c4e42" providerId="LiveId" clId="{B79B3BB6-BE0D-41FF-9837-DA5EA1766366}" dt="2024-04-12T09:05:35.052" v="273" actId="1076"/>
          <ac:cxnSpMkLst>
            <pc:docMk/>
            <pc:sldMk cId="3368625721" sldId="259"/>
            <ac:cxnSpMk id="22" creationId="{9899DB23-CA81-49C9-5DD1-3BBC9B271C8B}"/>
          </ac:cxnSpMkLst>
        </pc:cxnChg>
        <pc:cxnChg chg="add mod">
          <ac:chgData name="Daniela Grejtakova" userId="bbcbf34c4b1c4e42" providerId="LiveId" clId="{B79B3BB6-BE0D-41FF-9837-DA5EA1766366}" dt="2024-04-12T09:05:35.052" v="273" actId="1076"/>
          <ac:cxnSpMkLst>
            <pc:docMk/>
            <pc:sldMk cId="3368625721" sldId="259"/>
            <ac:cxnSpMk id="23" creationId="{64A42B0D-D012-8E7E-8F46-A92C23A6D19B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á snímk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350B3B55-E7D4-CFF2-8C42-D9404D517A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16761CFD-0DC3-1586-FC49-27BE956018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k-SK"/>
              <a:t>Kliknutím upravte štýl predlohy podnadpisu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84671BA2-372C-224A-CD4B-B0061659B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A02C5A94-3F9F-7C26-36CB-7E71D875D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F6E82378-36D4-E3F5-9961-5E08E4426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61570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z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349DF756-220F-046F-7DC4-F27F8D41EF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zvislý text 2">
            <a:extLst>
              <a:ext uri="{FF2B5EF4-FFF2-40B4-BE49-F238E27FC236}">
                <a16:creationId xmlns:a16="http://schemas.microsoft.com/office/drawing/2014/main" id="{80420AEB-AE28-4ABD-AFDB-0338236A9D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BA9A89A9-E9B1-BCDB-33B7-1EEBE8181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E5545A21-F522-BF00-6918-080AA1C60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A8E090D7-BFAC-9DBC-0B46-2EAD6F3FC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070082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Z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vislý nadpis 1">
            <a:extLst>
              <a:ext uri="{FF2B5EF4-FFF2-40B4-BE49-F238E27FC236}">
                <a16:creationId xmlns:a16="http://schemas.microsoft.com/office/drawing/2014/main" id="{87C0A993-BD8D-8FB8-DB99-2C1B69B136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zvislý text 2">
            <a:extLst>
              <a:ext uri="{FF2B5EF4-FFF2-40B4-BE49-F238E27FC236}">
                <a16:creationId xmlns:a16="http://schemas.microsoft.com/office/drawing/2014/main" id="{590E5814-B5B5-EF81-1E1E-A761538A46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082B355E-70D2-93DB-2FC6-29DFF1262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84A147A7-1073-A26D-05B7-0670267A5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0BDDB7FE-7D43-1D04-DFDC-94B8C2623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340544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C5B091D-B588-7254-BFFA-5D05DE2B25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sah 2">
            <a:extLst>
              <a:ext uri="{FF2B5EF4-FFF2-40B4-BE49-F238E27FC236}">
                <a16:creationId xmlns:a16="http://schemas.microsoft.com/office/drawing/2014/main" id="{4768C95A-D92D-F468-476C-47881E81D2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8EAB0155-02F3-697A-E4ED-8E8472B57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ED92DFE5-2294-624E-5B55-7AA5235A8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5CE7444B-0914-3077-DAD1-3CB3905F4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585765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Hlavička sekc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0596F67-3B20-D942-81EA-B5796B799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BE1AC144-E4EE-1F04-40F9-3B7D5D5581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5A2E12DA-2EE6-1A62-6C21-6252858ED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265B2E67-F793-08B8-33A5-805348706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A19C12AD-5F8C-F4CD-6037-BA3509E54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500223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83B51D-92BD-1793-243B-2F970C56E8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sah 2">
            <a:extLst>
              <a:ext uri="{FF2B5EF4-FFF2-40B4-BE49-F238E27FC236}">
                <a16:creationId xmlns:a16="http://schemas.microsoft.com/office/drawing/2014/main" id="{B798C9B8-992C-D5A0-5848-45E083B3AB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obsah 3">
            <a:extLst>
              <a:ext uri="{FF2B5EF4-FFF2-40B4-BE49-F238E27FC236}">
                <a16:creationId xmlns:a16="http://schemas.microsoft.com/office/drawing/2014/main" id="{1A153D56-5B22-0ABF-70E7-76024105F7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5" name="Zástupný objekt pre dátum 4">
            <a:extLst>
              <a:ext uri="{FF2B5EF4-FFF2-40B4-BE49-F238E27FC236}">
                <a16:creationId xmlns:a16="http://schemas.microsoft.com/office/drawing/2014/main" id="{5E3594E3-1029-C4E2-DFB0-08999C0F6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6" name="Zástupný objekt pre pätu 5">
            <a:extLst>
              <a:ext uri="{FF2B5EF4-FFF2-40B4-BE49-F238E27FC236}">
                <a16:creationId xmlns:a16="http://schemas.microsoft.com/office/drawing/2014/main" id="{F481F4D7-A828-775D-8521-B3968F243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objekt pre číslo snímky 6">
            <a:extLst>
              <a:ext uri="{FF2B5EF4-FFF2-40B4-BE49-F238E27FC236}">
                <a16:creationId xmlns:a16="http://schemas.microsoft.com/office/drawing/2014/main" id="{4467F3A6-897A-C915-E16E-EF96BB050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49798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E9EB4A2-0886-4B75-1D7C-666F0034F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94B1F07D-3633-2829-1CC4-1AD03B70FF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4" name="Zástupný objekt pre obsah 3">
            <a:extLst>
              <a:ext uri="{FF2B5EF4-FFF2-40B4-BE49-F238E27FC236}">
                <a16:creationId xmlns:a16="http://schemas.microsoft.com/office/drawing/2014/main" id="{A22DE6C1-E8EB-7C31-E4F4-0C8674EEA8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2CC2E001-6A5E-6255-5422-CF83768F94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6" name="Zástupný objekt pre obsah 5">
            <a:extLst>
              <a:ext uri="{FF2B5EF4-FFF2-40B4-BE49-F238E27FC236}">
                <a16:creationId xmlns:a16="http://schemas.microsoft.com/office/drawing/2014/main" id="{9496C9BA-9E36-FFDE-DB48-EBF44C24BF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7" name="Zástupný objekt pre dátum 6">
            <a:extLst>
              <a:ext uri="{FF2B5EF4-FFF2-40B4-BE49-F238E27FC236}">
                <a16:creationId xmlns:a16="http://schemas.microsoft.com/office/drawing/2014/main" id="{4F5B8862-ECD5-1FE7-3814-039846340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8" name="Zástupný objekt pre pätu 7">
            <a:extLst>
              <a:ext uri="{FF2B5EF4-FFF2-40B4-BE49-F238E27FC236}">
                <a16:creationId xmlns:a16="http://schemas.microsoft.com/office/drawing/2014/main" id="{A3D5444E-64F5-BAED-AB7D-7E25AAC40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9" name="Zástupný objekt pre číslo snímky 8">
            <a:extLst>
              <a:ext uri="{FF2B5EF4-FFF2-40B4-BE49-F238E27FC236}">
                <a16:creationId xmlns:a16="http://schemas.microsoft.com/office/drawing/2014/main" id="{DCA8CABD-BD2C-19BE-BFB7-138BE9242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9998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Len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DB38946-36DC-6D7A-5ABC-6CD9F53B05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dátum 2">
            <a:extLst>
              <a:ext uri="{FF2B5EF4-FFF2-40B4-BE49-F238E27FC236}">
                <a16:creationId xmlns:a16="http://schemas.microsoft.com/office/drawing/2014/main" id="{02C0C093-4EE4-56A8-078F-C42CB33F5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4" name="Zástupný objekt pre pätu 3">
            <a:extLst>
              <a:ext uri="{FF2B5EF4-FFF2-40B4-BE49-F238E27FC236}">
                <a16:creationId xmlns:a16="http://schemas.microsoft.com/office/drawing/2014/main" id="{5F846BAF-6B7D-97BF-AB13-2995B6648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5" name="Zástupný objekt pre číslo snímky 4">
            <a:extLst>
              <a:ext uri="{FF2B5EF4-FFF2-40B4-BE49-F238E27FC236}">
                <a16:creationId xmlns:a16="http://schemas.microsoft.com/office/drawing/2014/main" id="{A055F58B-BA01-6AE2-33F7-F2D3848DB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202053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objekt pre dátum 1">
            <a:extLst>
              <a:ext uri="{FF2B5EF4-FFF2-40B4-BE49-F238E27FC236}">
                <a16:creationId xmlns:a16="http://schemas.microsoft.com/office/drawing/2014/main" id="{7C9E71D6-60E3-7BC3-8575-DF08DE45F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3" name="Zástupný objekt pre pätu 2">
            <a:extLst>
              <a:ext uri="{FF2B5EF4-FFF2-40B4-BE49-F238E27FC236}">
                <a16:creationId xmlns:a16="http://schemas.microsoft.com/office/drawing/2014/main" id="{43F4BDCB-98D3-0FF5-604F-97EA3888F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4" name="Zástupný objekt pre číslo snímky 3">
            <a:extLst>
              <a:ext uri="{FF2B5EF4-FFF2-40B4-BE49-F238E27FC236}">
                <a16:creationId xmlns:a16="http://schemas.microsoft.com/office/drawing/2014/main" id="{9CE0AD63-2743-A18C-A16F-4D929F8D2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677413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5A0A3021-A30F-D8C6-6B9A-DA49A27B85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sah 2">
            <a:extLst>
              <a:ext uri="{FF2B5EF4-FFF2-40B4-BE49-F238E27FC236}">
                <a16:creationId xmlns:a16="http://schemas.microsoft.com/office/drawing/2014/main" id="{F9A6022B-A614-C1B2-89DB-7C123742D7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12C00162-79BE-2C43-ECD3-ABBDE6AAA6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5" name="Zástupný objekt pre dátum 4">
            <a:extLst>
              <a:ext uri="{FF2B5EF4-FFF2-40B4-BE49-F238E27FC236}">
                <a16:creationId xmlns:a16="http://schemas.microsoft.com/office/drawing/2014/main" id="{53333343-1280-C49D-3B10-3DEB16C2F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6" name="Zástupný objekt pre pätu 5">
            <a:extLst>
              <a:ext uri="{FF2B5EF4-FFF2-40B4-BE49-F238E27FC236}">
                <a16:creationId xmlns:a16="http://schemas.microsoft.com/office/drawing/2014/main" id="{A7440059-AF2A-CACB-4A23-93F1B86D9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objekt pre číslo snímky 6">
            <a:extLst>
              <a:ext uri="{FF2B5EF4-FFF2-40B4-BE49-F238E27FC236}">
                <a16:creationId xmlns:a16="http://schemas.microsoft.com/office/drawing/2014/main" id="{B2F9FFB8-BE5F-1449-499B-22367F297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056386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ok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720F4C0D-973D-CEAB-66CB-827427317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rázok 2">
            <a:extLst>
              <a:ext uri="{FF2B5EF4-FFF2-40B4-BE49-F238E27FC236}">
                <a16:creationId xmlns:a16="http://schemas.microsoft.com/office/drawing/2014/main" id="{0CA29512-D699-9754-F8F2-7DFA086DCF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k-SK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2E5AC346-B06C-F649-6F70-9231C07CB5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5" name="Zástupný objekt pre dátum 4">
            <a:extLst>
              <a:ext uri="{FF2B5EF4-FFF2-40B4-BE49-F238E27FC236}">
                <a16:creationId xmlns:a16="http://schemas.microsoft.com/office/drawing/2014/main" id="{C96A1ECA-2DA4-B334-95A8-D42A5FAEAC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6" name="Zástupný objekt pre pätu 5">
            <a:extLst>
              <a:ext uri="{FF2B5EF4-FFF2-40B4-BE49-F238E27FC236}">
                <a16:creationId xmlns:a16="http://schemas.microsoft.com/office/drawing/2014/main" id="{21233FB1-A296-1C3A-891A-03B06DF28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objekt pre číslo snímky 6">
            <a:extLst>
              <a:ext uri="{FF2B5EF4-FFF2-40B4-BE49-F238E27FC236}">
                <a16:creationId xmlns:a16="http://schemas.microsoft.com/office/drawing/2014/main" id="{7FF5EA28-AF3C-B64C-B661-D2AC993FB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137322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objekt pre nadpis 1">
            <a:extLst>
              <a:ext uri="{FF2B5EF4-FFF2-40B4-BE49-F238E27FC236}">
                <a16:creationId xmlns:a16="http://schemas.microsoft.com/office/drawing/2014/main" id="{83108648-4024-6E54-8126-DBE390AA9D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97804B70-4C89-4FC1-F748-A0CECEE7A9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4BBF81A9-0D44-4EA6-D650-F875E7E9C7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514443-97AC-4FAE-B4E5-947AE376B9E8}" type="datetimeFigureOut">
              <a:rPr lang="sk-SK" smtClean="0"/>
              <a:t>8. 6. 2024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4C34A6CE-A3E3-C0E3-98B1-2E62E6ADBD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92AD3C55-7898-CF7C-9AF9-CFF2FDCEF1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1558F4-7DE6-4372-9B36-82DDB3144506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675789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k-S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BlokTextu 4">
            <a:extLst>
              <a:ext uri="{FF2B5EF4-FFF2-40B4-BE49-F238E27FC236}">
                <a16:creationId xmlns:a16="http://schemas.microsoft.com/office/drawing/2014/main" id="{F4FB9BE5-4250-FDD0-4D18-8E146522EF20}"/>
              </a:ext>
            </a:extLst>
          </p:cNvPr>
          <p:cNvSpPr txBox="1"/>
          <p:nvPr/>
        </p:nvSpPr>
        <p:spPr>
          <a:xfrm rot="16200000">
            <a:off x="1538590" y="2476819"/>
            <a:ext cx="1149748" cy="24622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</a:p>
        </p:txBody>
      </p:sp>
      <p:sp>
        <p:nvSpPr>
          <p:cNvPr id="6" name="BlokTextu 5">
            <a:extLst>
              <a:ext uri="{FF2B5EF4-FFF2-40B4-BE49-F238E27FC236}">
                <a16:creationId xmlns:a16="http://schemas.microsoft.com/office/drawing/2014/main" id="{35A8592C-99B4-8F25-0B94-86AE0B0D64B5}"/>
              </a:ext>
            </a:extLst>
          </p:cNvPr>
          <p:cNvSpPr txBox="1"/>
          <p:nvPr/>
        </p:nvSpPr>
        <p:spPr>
          <a:xfrm rot="16200000">
            <a:off x="1605632" y="3686547"/>
            <a:ext cx="1015661" cy="24622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eening</a:t>
            </a:r>
          </a:p>
        </p:txBody>
      </p:sp>
      <p:sp>
        <p:nvSpPr>
          <p:cNvPr id="7" name="BlokTextu 6">
            <a:extLst>
              <a:ext uri="{FF2B5EF4-FFF2-40B4-BE49-F238E27FC236}">
                <a16:creationId xmlns:a16="http://schemas.microsoft.com/office/drawing/2014/main" id="{258D1F6C-C102-AF36-6D8C-9644CEE46D1C}"/>
              </a:ext>
            </a:extLst>
          </p:cNvPr>
          <p:cNvSpPr txBox="1"/>
          <p:nvPr/>
        </p:nvSpPr>
        <p:spPr>
          <a:xfrm rot="16200000">
            <a:off x="1618120" y="4837547"/>
            <a:ext cx="1015660" cy="24622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igibility</a:t>
            </a:r>
          </a:p>
        </p:txBody>
      </p:sp>
      <p:sp>
        <p:nvSpPr>
          <p:cNvPr id="8" name="BlokTextu 7">
            <a:extLst>
              <a:ext uri="{FF2B5EF4-FFF2-40B4-BE49-F238E27FC236}">
                <a16:creationId xmlns:a16="http://schemas.microsoft.com/office/drawing/2014/main" id="{457655E7-7C20-C570-C003-8196B7A99169}"/>
              </a:ext>
            </a:extLst>
          </p:cNvPr>
          <p:cNvSpPr txBox="1"/>
          <p:nvPr/>
        </p:nvSpPr>
        <p:spPr>
          <a:xfrm rot="16200000">
            <a:off x="1660042" y="5959825"/>
            <a:ext cx="931816" cy="24622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pl-P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</a:p>
        </p:txBody>
      </p:sp>
      <p:sp>
        <p:nvSpPr>
          <p:cNvPr id="10" name="BlokTextu 9">
            <a:extLst>
              <a:ext uri="{FF2B5EF4-FFF2-40B4-BE49-F238E27FC236}">
                <a16:creationId xmlns:a16="http://schemas.microsoft.com/office/drawing/2014/main" id="{ECAE5202-F549-4064-F796-2B780E79FDFE}"/>
              </a:ext>
            </a:extLst>
          </p:cNvPr>
          <p:cNvSpPr txBox="1"/>
          <p:nvPr/>
        </p:nvSpPr>
        <p:spPr>
          <a:xfrm>
            <a:off x="2702845" y="2220633"/>
            <a:ext cx="2894373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l-P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Pubmed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pl-P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b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ciences, SCOPUS</a:t>
            </a:r>
            <a:r>
              <a:rPr lang="pl-P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oogle Scholar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bases </a:t>
            </a:r>
            <a:r>
              <a:rPr lang="en-US" sz="1000" b="0" i="0" dirty="0">
                <a:solidFill>
                  <a:srgbClr val="20202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linicaltrials.gov </a:t>
            </a:r>
            <a:endParaRPr lang="pl-PL" sz="1000" b="0" i="0" dirty="0">
              <a:solidFill>
                <a:srgbClr val="20202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00" b="0" i="0" dirty="0">
                <a:solidFill>
                  <a:srgbClr val="20202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ntil</a:t>
            </a:r>
            <a:r>
              <a:rPr lang="pl-PL" sz="1000" b="0" i="0" dirty="0">
                <a:solidFill>
                  <a:srgbClr val="20202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00" dirty="0">
                <a:solidFill>
                  <a:srgbClr val="2020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ember</a:t>
            </a:r>
            <a:r>
              <a:rPr lang="en-US" sz="1000" b="0" i="0" dirty="0">
                <a:solidFill>
                  <a:srgbClr val="20202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023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</a:t>
            </a:r>
            <a:r>
              <a:rPr lang="pl-P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9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34458C7A-4A72-CBF4-B4D4-E04EA6221463}"/>
              </a:ext>
            </a:extLst>
          </p:cNvPr>
          <p:cNvSpPr txBox="1"/>
          <p:nvPr/>
        </p:nvSpPr>
        <p:spPr>
          <a:xfrm>
            <a:off x="7560907" y="2349661"/>
            <a:ext cx="3361639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duplication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52</a:t>
            </a:r>
          </a:p>
        </p:txBody>
      </p:sp>
      <p:sp>
        <p:nvSpPr>
          <p:cNvPr id="14" name="BlokTextu 13">
            <a:extLst>
              <a:ext uri="{FF2B5EF4-FFF2-40B4-BE49-F238E27FC236}">
                <a16:creationId xmlns:a16="http://schemas.microsoft.com/office/drawing/2014/main" id="{9446ACD4-404D-D3F3-F6D0-276F94909D10}"/>
              </a:ext>
            </a:extLst>
          </p:cNvPr>
          <p:cNvSpPr txBox="1"/>
          <p:nvPr/>
        </p:nvSpPr>
        <p:spPr>
          <a:xfrm>
            <a:off x="2702847" y="3564666"/>
            <a:ext cx="2894372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ords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eened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7</a:t>
            </a:r>
          </a:p>
        </p:txBody>
      </p:sp>
      <p:sp>
        <p:nvSpPr>
          <p:cNvPr id="16" name="BlokTextu 15">
            <a:extLst>
              <a:ext uri="{FF2B5EF4-FFF2-40B4-BE49-F238E27FC236}">
                <a16:creationId xmlns:a16="http://schemas.microsoft.com/office/drawing/2014/main" id="{83C01A86-470E-5FD4-5639-6D8FA8163D93}"/>
              </a:ext>
            </a:extLst>
          </p:cNvPr>
          <p:cNvSpPr txBox="1"/>
          <p:nvPr/>
        </p:nvSpPr>
        <p:spPr>
          <a:xfrm>
            <a:off x="7560908" y="3247214"/>
            <a:ext cx="3361639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l-P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s excluded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views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ference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stracts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als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cocimuzab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46</a:t>
            </a:r>
          </a:p>
        </p:txBody>
      </p:sp>
      <p:sp>
        <p:nvSpPr>
          <p:cNvPr id="18" name="BlokTextu 17">
            <a:extLst>
              <a:ext uri="{FF2B5EF4-FFF2-40B4-BE49-F238E27FC236}">
                <a16:creationId xmlns:a16="http://schemas.microsoft.com/office/drawing/2014/main" id="{8B305C6A-6899-31D1-36F6-C323FDD7A17A}"/>
              </a:ext>
            </a:extLst>
          </p:cNvPr>
          <p:cNvSpPr txBox="1"/>
          <p:nvPr/>
        </p:nvSpPr>
        <p:spPr>
          <a:xfrm>
            <a:off x="2702847" y="4775329"/>
            <a:ext cx="2894372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ll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xt of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iginal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51</a:t>
            </a:r>
          </a:p>
        </p:txBody>
      </p:sp>
      <p:sp>
        <p:nvSpPr>
          <p:cNvPr id="20" name="BlokTextu 19">
            <a:extLst>
              <a:ext uri="{FF2B5EF4-FFF2-40B4-BE49-F238E27FC236}">
                <a16:creationId xmlns:a16="http://schemas.microsoft.com/office/drawing/2014/main" id="{5789F68F-67E2-452C-DABF-13DAB0503E47}"/>
              </a:ext>
            </a:extLst>
          </p:cNvPr>
          <p:cNvSpPr txBox="1"/>
          <p:nvPr/>
        </p:nvSpPr>
        <p:spPr>
          <a:xfrm>
            <a:off x="7560907" y="4775329"/>
            <a:ext cx="3361639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publications without data of interest</a:t>
            </a:r>
            <a:endParaRPr lang="pl-PL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44</a:t>
            </a:r>
          </a:p>
        </p:txBody>
      </p:sp>
      <p:sp>
        <p:nvSpPr>
          <p:cNvPr id="22" name="BlokTextu 21">
            <a:extLst>
              <a:ext uri="{FF2B5EF4-FFF2-40B4-BE49-F238E27FC236}">
                <a16:creationId xmlns:a16="http://schemas.microsoft.com/office/drawing/2014/main" id="{3AE1DAA4-71F3-93B9-9E48-8035A81005AE}"/>
              </a:ext>
            </a:extLst>
          </p:cNvPr>
          <p:cNvSpPr txBox="1"/>
          <p:nvPr/>
        </p:nvSpPr>
        <p:spPr>
          <a:xfrm>
            <a:off x="2702847" y="6048899"/>
            <a:ext cx="2894372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</a:t>
            </a:r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sk-SK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sk-SK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</a:t>
            </a:r>
          </a:p>
        </p:txBody>
      </p:sp>
      <p:cxnSp>
        <p:nvCxnSpPr>
          <p:cNvPr id="13" name="Rovná spojovacia šípka 12">
            <a:extLst>
              <a:ext uri="{FF2B5EF4-FFF2-40B4-BE49-F238E27FC236}">
                <a16:creationId xmlns:a16="http://schemas.microsoft.com/office/drawing/2014/main" id="{57E99F59-C795-F224-AC04-E3A6A0F57A30}"/>
              </a:ext>
            </a:extLst>
          </p:cNvPr>
          <p:cNvCxnSpPr>
            <a:cxnSpLocks/>
          </p:cNvCxnSpPr>
          <p:nvPr/>
        </p:nvCxnSpPr>
        <p:spPr>
          <a:xfrm>
            <a:off x="5597218" y="2580852"/>
            <a:ext cx="1836284" cy="101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BlokTextu 32">
            <a:extLst>
              <a:ext uri="{FF2B5EF4-FFF2-40B4-BE49-F238E27FC236}">
                <a16:creationId xmlns:a16="http://schemas.microsoft.com/office/drawing/2014/main" id="{4B979C71-7240-4B75-582A-BEBC0CCAB112}"/>
              </a:ext>
            </a:extLst>
          </p:cNvPr>
          <p:cNvSpPr txBox="1"/>
          <p:nvPr/>
        </p:nvSpPr>
        <p:spPr>
          <a:xfrm>
            <a:off x="1850065" y="1688656"/>
            <a:ext cx="623628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0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SMA flow diagram</a:t>
            </a:r>
            <a:endParaRPr lang="sk-SK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5" name="Rovná spojovacia šípka 74">
            <a:extLst>
              <a:ext uri="{FF2B5EF4-FFF2-40B4-BE49-F238E27FC236}">
                <a16:creationId xmlns:a16="http://schemas.microsoft.com/office/drawing/2014/main" id="{2BC9725C-EA7E-8425-9315-1CFAB0E9C84F}"/>
              </a:ext>
            </a:extLst>
          </p:cNvPr>
          <p:cNvCxnSpPr>
            <a:cxnSpLocks/>
          </p:cNvCxnSpPr>
          <p:nvPr/>
        </p:nvCxnSpPr>
        <p:spPr>
          <a:xfrm>
            <a:off x="4150032" y="4127290"/>
            <a:ext cx="0" cy="5612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Rovná spojovacia šípka 75">
            <a:extLst>
              <a:ext uri="{FF2B5EF4-FFF2-40B4-BE49-F238E27FC236}">
                <a16:creationId xmlns:a16="http://schemas.microsoft.com/office/drawing/2014/main" id="{08E3043D-6ADF-082C-3570-5DCC5ADE048D}"/>
              </a:ext>
            </a:extLst>
          </p:cNvPr>
          <p:cNvCxnSpPr>
            <a:cxnSpLocks/>
          </p:cNvCxnSpPr>
          <p:nvPr/>
        </p:nvCxnSpPr>
        <p:spPr>
          <a:xfrm>
            <a:off x="5597219" y="3756189"/>
            <a:ext cx="183628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Rovná spojovacia šípka 76">
            <a:extLst>
              <a:ext uri="{FF2B5EF4-FFF2-40B4-BE49-F238E27FC236}">
                <a16:creationId xmlns:a16="http://schemas.microsoft.com/office/drawing/2014/main" id="{ADCF4E17-5EA3-6CD4-692F-DDC6158FEA50}"/>
              </a:ext>
            </a:extLst>
          </p:cNvPr>
          <p:cNvCxnSpPr>
            <a:cxnSpLocks/>
          </p:cNvCxnSpPr>
          <p:nvPr/>
        </p:nvCxnSpPr>
        <p:spPr>
          <a:xfrm>
            <a:off x="4154509" y="5359698"/>
            <a:ext cx="0" cy="5612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Rovná spojovacia šípka 77">
            <a:extLst>
              <a:ext uri="{FF2B5EF4-FFF2-40B4-BE49-F238E27FC236}">
                <a16:creationId xmlns:a16="http://schemas.microsoft.com/office/drawing/2014/main" id="{5713185A-6972-EDEC-1606-584722A2BCB7}"/>
              </a:ext>
            </a:extLst>
          </p:cNvPr>
          <p:cNvCxnSpPr>
            <a:cxnSpLocks/>
          </p:cNvCxnSpPr>
          <p:nvPr/>
        </p:nvCxnSpPr>
        <p:spPr>
          <a:xfrm>
            <a:off x="5597219" y="4962356"/>
            <a:ext cx="183628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BlokTextu 24">
            <a:extLst>
              <a:ext uri="{FF2B5EF4-FFF2-40B4-BE49-F238E27FC236}">
                <a16:creationId xmlns:a16="http://schemas.microsoft.com/office/drawing/2014/main" id="{AA8BC700-C1D1-64C0-6677-D5AD83B82ACE}"/>
              </a:ext>
            </a:extLst>
          </p:cNvPr>
          <p:cNvSpPr txBox="1"/>
          <p:nvPr/>
        </p:nvSpPr>
        <p:spPr>
          <a:xfrm>
            <a:off x="0" y="-33562"/>
            <a:ext cx="1103376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diovascular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rug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apy</a:t>
            </a:r>
            <a:endParaRPr lang="sk-SK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SK9 and lipid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lism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tic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ant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rent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apie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diovascular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comes</a:t>
            </a:r>
            <a:endParaRPr lang="sk-SK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niela Grejtakova1, Iveta Boronova1, Jarmila Bernasovska1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efano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llosta2</a:t>
            </a:r>
          </a:p>
          <a:p>
            <a:endParaRPr lang="sk-SK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oratory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tic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epartment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logy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culty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manitie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tural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ience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versity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ov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7 November 1, 08001, Slovakia</a:t>
            </a: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Department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rmacological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molecular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ience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"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dolfo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oletti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"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versità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li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ano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a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zaretti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, 20133, Milan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taly</a:t>
            </a:r>
            <a:endParaRPr lang="sk-SK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sk-SK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thor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niela Grejtakova, PhD.</a:t>
            </a: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logy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culty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manitie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tural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iences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versity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sk-SK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ov</a:t>
            </a:r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lovakia</a:t>
            </a: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ail: daniela.grejtakova@gmail.com; daniela.grejtakova@unipo.sk</a:t>
            </a:r>
          </a:p>
          <a:p>
            <a:r>
              <a:rPr lang="sk-SK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CID: 0000-0003-4688-2662</a:t>
            </a:r>
          </a:p>
        </p:txBody>
      </p:sp>
      <p:cxnSp>
        <p:nvCxnSpPr>
          <p:cNvPr id="9" name="Rovná spojovacia šípka 8">
            <a:extLst>
              <a:ext uri="{FF2B5EF4-FFF2-40B4-BE49-F238E27FC236}">
                <a16:creationId xmlns:a16="http://schemas.microsoft.com/office/drawing/2014/main" id="{E39CB17E-66CF-33EA-1659-B8A87A526C26}"/>
              </a:ext>
            </a:extLst>
          </p:cNvPr>
          <p:cNvCxnSpPr>
            <a:cxnSpLocks/>
          </p:cNvCxnSpPr>
          <p:nvPr/>
        </p:nvCxnSpPr>
        <p:spPr>
          <a:xfrm>
            <a:off x="4150032" y="2966574"/>
            <a:ext cx="0" cy="5612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46418112"/>
      </p:ext>
    </p:extLst>
  </p:cSld>
  <p:clrMapOvr>
    <a:masterClrMapping/>
  </p:clrMapOvr>
</p:sld>
</file>

<file path=ppt/theme/theme1.xml><?xml version="1.0" encoding="utf-8"?>
<a:theme xmlns:a="http://schemas.openxmlformats.org/drawingml/2006/main" name="Motív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209</Words>
  <Application>Microsoft Office PowerPoint</Application>
  <PresentationFormat>Širokouhlá</PresentationFormat>
  <Paragraphs>36</Paragraphs>
  <Slides>1</Slides>
  <Notes>0</Notes>
  <HiddenSlides>0</HiddenSlides>
  <MMClips>0</MMClips>
  <ScaleCrop>false</ScaleCrop>
  <HeadingPairs>
    <vt:vector size="6" baseType="variant">
      <vt:variant>
        <vt:lpstr>Použité písma</vt:lpstr>
      </vt:variant>
      <vt:variant>
        <vt:i4>4</vt:i4>
      </vt:variant>
      <vt:variant>
        <vt:lpstr>Motív</vt:lpstr>
      </vt:variant>
      <vt:variant>
        <vt:i4>1</vt:i4>
      </vt:variant>
      <vt:variant>
        <vt:lpstr>Nadpisy snímok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Motív Office</vt:lpstr>
      <vt:lpstr>Prezentáci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ácia programu PowerPoint</dc:title>
  <dc:creator>Daniela Grejtakova</dc:creator>
  <cp:lastModifiedBy>Daniela Grejtakova</cp:lastModifiedBy>
  <cp:revision>2</cp:revision>
  <dcterms:created xsi:type="dcterms:W3CDTF">2024-04-03T12:44:48Z</dcterms:created>
  <dcterms:modified xsi:type="dcterms:W3CDTF">2024-06-08T09:38:49Z</dcterms:modified>
</cp:coreProperties>
</file>